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64" r:id="rId3"/>
    <p:sldId id="265" r:id="rId4"/>
    <p:sldId id="266" r:id="rId5"/>
    <p:sldId id="268" r:id="rId6"/>
    <p:sldId id="267" r:id="rId7"/>
    <p:sldId id="269" r:id="rId8"/>
    <p:sldId id="270" r:id="rId9"/>
    <p:sldId id="257" r:id="rId10"/>
    <p:sldId id="258" r:id="rId11"/>
    <p:sldId id="259" r:id="rId12"/>
    <p:sldId id="260" r:id="rId13"/>
    <p:sldId id="262" r:id="rId14"/>
    <p:sldId id="261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82" d="100"/>
          <a:sy n="82" d="100"/>
        </p:scale>
        <p:origin x="58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17E168-6D6F-41C3-A93E-3B50684F72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168A43-160D-47A1-A23C-C2BF1F0204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39441B-C945-44C3-942E-DCD0F49D2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709D67-C71E-42A3-8521-FF2675AC0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378174-B0C4-493A-BAE5-BF412CE40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027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A94237-1BA2-435E-ACDC-AFE11ADBA1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4DB132-735E-4AFE-959A-32C11E15A0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FB2B5F-B833-4483-86AF-DAE865491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760F40-B366-43AD-9D3E-8258DD1B93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CD8219-5049-4A18-B764-B5230B78A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260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392970-37D8-4BEC-8487-1C7010243C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A65E40-F7B0-4097-BAA3-46CAF93895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7C59BF-86B6-44BD-99B9-515E6A127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25A0DD-20B4-4A51-8BBA-3EFB2D5BB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5E3BDA-AFED-4066-AFDB-9C2922008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08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C21C3-6D55-4477-BE14-97395C6EA1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92A86D-D452-4FB1-B7E4-187C8452C4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50B255-4E4C-45B9-B904-0AF2C23FE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2BBD82-C73B-4E41-94B0-123345F11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24560B-94DC-4D5C-A193-2F65501A9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607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FA3554-6A6C-4F17-9C3A-82635385D2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657C13-4843-46C5-AAEF-DA7F510708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5A96B6-15FC-4394-9C26-23FA66268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A374BD-18E4-4404-A2D2-B32A6CBA5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BD654F-B5A2-4E02-BF5B-DA1FBED6B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947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6D131-54E7-410C-9A0C-F0BA131288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15119C-140F-4DC2-83C0-5F2BAFBBDC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4CECBD-1537-4B21-A178-9677E8B56B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6B0302-F83E-40D9-B203-A64F51118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530C12-C1AF-45BB-887D-18CBD14F8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3A21A4-DF54-4DC3-BC3C-3AC97243A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840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91CE0C-701A-4058-BC2E-42F3D45C61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CE8CE2-C68C-435A-A60F-49ACD332CB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A4E7B8-5AB2-47C5-A756-716A8CEE87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8A11FB-9528-4ED6-AC01-D621AD3C8A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505936-71D4-452C-8477-A7A72E72D4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8E5658-2C2B-4445-B391-63C61FF1D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E011C52-B29D-4864-A331-93C1BE835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E176FE-74A0-49FE-BA51-FC76181B6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446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5EBAA-A510-41ED-B463-6E4AF4FD06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8110B8-4FCD-4AE1-A02F-EFFA2E7DFB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0082FD7-EE2A-4EAF-95DA-2C301B67B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F964CC1-775C-4F57-A301-F2A3141F8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712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49B702-4ABD-4754-8B59-2D52DD5B5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8D2BEE-7DC4-48D5-82A9-88A5ECB3D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86E4E8-AABC-400C-B976-052903EBD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360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74E80D-F0AD-4319-A1C5-52821C8B23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DF1879-411E-4C65-8CC8-01A7169CE9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F4DEA1-80F6-4BF4-B148-115A0F9559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FB2C15-1857-4223-AD30-08FEA9974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322BDB-964A-4CE4-AAFA-658161B16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05D701-8E86-4FA2-AA7A-27EF25DD9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941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B79CDF-7F1E-4111-AC83-BA750FBA73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02CA1FC-EA7E-4CC8-A765-BB0239D11E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1A6370-2359-4037-8100-BD95C59C39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7D6830-35E5-4A9E-9148-554473409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4C3A92-8DB7-4EAC-BEEA-8AFF9875D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BF24C8-6B31-44C4-B4E3-3F69B389C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631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E07836-B90A-48C7-B721-062CF9146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3ADF44-106D-4DF4-82A6-9A9EB77BF9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FC5E51-286E-40F7-924F-697B14CF2E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76809E-12C4-4326-ABC2-DCCE0EA7156E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48C627-3AB1-4759-ACC8-8BFB80A27F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A069DB-1F4B-4A91-B6E8-BD74DF8768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C78FE3-65D0-4FF2-A3F3-D48A7821F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325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1F9F1E-BA66-184B-0532-CD99C76B2C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576480"/>
            <a:ext cx="10515600" cy="1325563"/>
          </a:xfrm>
        </p:spPr>
        <p:txBody>
          <a:bodyPr/>
          <a:lstStyle/>
          <a:p>
            <a:pPr algn="ctr"/>
            <a: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Supplementary Figure 1c</a:t>
            </a:r>
            <a:b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</a:br>
            <a:b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</a:br>
            <a:r>
              <a:rPr lang="en-US" sz="18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Western blot detection of CD9 and LRRK2 proteins of 5 urine EV samples isolated by EVtrap or ultracentrifugation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3543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26183A9-B292-4DD7-AA97-4E4A776CCA46}"/>
              </a:ext>
            </a:extLst>
          </p:cNvPr>
          <p:cNvSpPr txBox="1"/>
          <p:nvPr/>
        </p:nvSpPr>
        <p:spPr>
          <a:xfrm>
            <a:off x="942975" y="1790700"/>
            <a:ext cx="4224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064   062   066   067   068   071   072   073   074   076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448313-133B-4BD8-BA3E-D4A2A0697EED}"/>
              </a:ext>
            </a:extLst>
          </p:cNvPr>
          <p:cNvSpPr txBox="1"/>
          <p:nvPr/>
        </p:nvSpPr>
        <p:spPr>
          <a:xfrm>
            <a:off x="942975" y="3752850"/>
            <a:ext cx="4224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077   078   079   081   082   083   084   085   089   09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7476546-1F0D-4A4D-AE27-A95670AD867E}"/>
              </a:ext>
            </a:extLst>
          </p:cNvPr>
          <p:cNvSpPr txBox="1"/>
          <p:nvPr/>
        </p:nvSpPr>
        <p:spPr>
          <a:xfrm>
            <a:off x="6457949" y="1790700"/>
            <a:ext cx="46185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094   097   099   101   102   103   104   105   107   108   10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0A904BF-1F86-4BAE-A1F0-959EDFCCD12B}"/>
              </a:ext>
            </a:extLst>
          </p:cNvPr>
          <p:cNvSpPr txBox="1"/>
          <p:nvPr/>
        </p:nvSpPr>
        <p:spPr>
          <a:xfrm>
            <a:off x="6457949" y="3752849"/>
            <a:ext cx="46185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113   114   115   120   121   123   206   207   208   209   210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B7D924A9-F0BE-448F-BFF1-DF671902849E}"/>
              </a:ext>
            </a:extLst>
          </p:cNvPr>
          <p:cNvGrpSpPr/>
          <p:nvPr/>
        </p:nvGrpSpPr>
        <p:grpSpPr>
          <a:xfrm>
            <a:off x="844590" y="4060625"/>
            <a:ext cx="4324748" cy="1283095"/>
            <a:chOff x="844590" y="4060625"/>
            <a:chExt cx="4324748" cy="1283095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3C713966-FC59-4838-965B-30CC9719C4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814" t="5589" r="2895" b="21188"/>
            <a:stretch/>
          </p:blipFill>
          <p:spPr>
            <a:xfrm>
              <a:off x="844590" y="4060626"/>
              <a:ext cx="4324748" cy="1283094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6C17704-7B8C-4A5F-B60A-E6EA0FE717E8}"/>
                </a:ext>
              </a:extLst>
            </p:cNvPr>
            <p:cNvSpPr txBox="1"/>
            <p:nvPr/>
          </p:nvSpPr>
          <p:spPr>
            <a:xfrm>
              <a:off x="851472" y="406062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6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6E011D80-6A14-4D34-96E6-901A3F31868C}"/>
              </a:ext>
            </a:extLst>
          </p:cNvPr>
          <p:cNvSpPr txBox="1"/>
          <p:nvPr/>
        </p:nvSpPr>
        <p:spPr>
          <a:xfrm>
            <a:off x="5382126" y="529390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9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2D339025-2854-440E-B544-11702E650F74}"/>
              </a:ext>
            </a:extLst>
          </p:cNvPr>
          <p:cNvGrpSpPr/>
          <p:nvPr/>
        </p:nvGrpSpPr>
        <p:grpSpPr>
          <a:xfrm>
            <a:off x="6328472" y="2098475"/>
            <a:ext cx="4764256" cy="1283094"/>
            <a:chOff x="6328472" y="2098475"/>
            <a:chExt cx="4764256" cy="1283094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25EC350A-88F2-465F-A0D0-55498C655A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13" t="22545" r="50264" b="5302"/>
            <a:stretch/>
          </p:blipFill>
          <p:spPr>
            <a:xfrm>
              <a:off x="6328472" y="2098476"/>
              <a:ext cx="4764256" cy="1283093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90709BB-DB74-4EE8-9AAF-83C92CAB5CB0}"/>
                </a:ext>
              </a:extLst>
            </p:cNvPr>
            <p:cNvSpPr txBox="1"/>
            <p:nvPr/>
          </p:nvSpPr>
          <p:spPr>
            <a:xfrm>
              <a:off x="6332733" y="209847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7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F2E4F3F6-ACD5-4901-9316-7C37C002650E}"/>
              </a:ext>
            </a:extLst>
          </p:cNvPr>
          <p:cNvGrpSpPr/>
          <p:nvPr/>
        </p:nvGrpSpPr>
        <p:grpSpPr>
          <a:xfrm>
            <a:off x="6328472" y="4060625"/>
            <a:ext cx="4745919" cy="1283094"/>
            <a:chOff x="6328472" y="4060625"/>
            <a:chExt cx="4745919" cy="1283094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C6A40518-CACE-42A0-B283-6D853A5ADB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1776" t="14219" b="13350"/>
            <a:stretch/>
          </p:blipFill>
          <p:spPr>
            <a:xfrm>
              <a:off x="6328472" y="4060625"/>
              <a:ext cx="4745919" cy="1283094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C4BB66F-4CA9-4A88-9E52-BFF989400B0C}"/>
                </a:ext>
              </a:extLst>
            </p:cNvPr>
            <p:cNvSpPr txBox="1"/>
            <p:nvPr/>
          </p:nvSpPr>
          <p:spPr>
            <a:xfrm>
              <a:off x="6332733" y="406062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8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B34305BE-8EC6-4B2D-8611-ED2084101B1F}"/>
              </a:ext>
            </a:extLst>
          </p:cNvPr>
          <p:cNvGrpSpPr/>
          <p:nvPr/>
        </p:nvGrpSpPr>
        <p:grpSpPr>
          <a:xfrm>
            <a:off x="843451" y="2098475"/>
            <a:ext cx="4332278" cy="1283094"/>
            <a:chOff x="843451" y="2098475"/>
            <a:chExt cx="4332278" cy="1283094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AB5E4C33-A6C4-4A53-8E29-95B8F30578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684" t="13484" r="51942" b="13484"/>
            <a:stretch/>
          </p:blipFill>
          <p:spPr>
            <a:xfrm>
              <a:off x="844590" y="2098475"/>
              <a:ext cx="4331139" cy="1283094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9D0A63C-F405-425E-9433-E69AE62E93B8}"/>
                </a:ext>
              </a:extLst>
            </p:cNvPr>
            <p:cNvSpPr txBox="1"/>
            <p:nvPr/>
          </p:nvSpPr>
          <p:spPr>
            <a:xfrm>
              <a:off x="843451" y="209847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5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41B140F2-A2DC-E934-9782-5286EA44B078}"/>
              </a:ext>
            </a:extLst>
          </p:cNvPr>
          <p:cNvSpPr txBox="1"/>
          <p:nvPr/>
        </p:nvSpPr>
        <p:spPr>
          <a:xfrm>
            <a:off x="2367642" y="6316261"/>
            <a:ext cx="9043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0973E6C-1201-3F8C-CFB0-FF58E2166F56}"/>
              </a:ext>
            </a:extLst>
          </p:cNvPr>
          <p:cNvSpPr txBox="1"/>
          <p:nvPr/>
        </p:nvSpPr>
        <p:spPr>
          <a:xfrm>
            <a:off x="2717055" y="5848511"/>
            <a:ext cx="72185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CD9 (clone D3H4P; Cell Signaling Technology) at 1:5,000 ratio</a:t>
            </a:r>
          </a:p>
        </p:txBody>
      </p:sp>
    </p:spTree>
    <p:extLst>
      <p:ext uri="{BB962C8B-B14F-4D97-AF65-F5344CB8AC3E}">
        <p14:creationId xmlns:p14="http://schemas.microsoft.com/office/powerpoint/2010/main" val="2995554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604BF8F-2C74-4586-BFFB-61B998036668}"/>
              </a:ext>
            </a:extLst>
          </p:cNvPr>
          <p:cNvSpPr txBox="1"/>
          <p:nvPr/>
        </p:nvSpPr>
        <p:spPr>
          <a:xfrm>
            <a:off x="910891" y="1790700"/>
            <a:ext cx="4224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001   003   005   006   008   009   010   011   012   01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C2F036D-F477-4A94-B721-84550A84E901}"/>
              </a:ext>
            </a:extLst>
          </p:cNvPr>
          <p:cNvSpPr txBox="1"/>
          <p:nvPr/>
        </p:nvSpPr>
        <p:spPr>
          <a:xfrm>
            <a:off x="918912" y="3752850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015   016   019   021   023   024   025   026   027   02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2024C3D-095E-404B-BAC6-3BC26FFC459A}"/>
              </a:ext>
            </a:extLst>
          </p:cNvPr>
          <p:cNvSpPr txBox="1"/>
          <p:nvPr/>
        </p:nvSpPr>
        <p:spPr>
          <a:xfrm>
            <a:off x="6385760" y="1790700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029   031   036   039   041   042   043   044   045   048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9F7AC69-55AA-4712-BFC9-910E63836DDB}"/>
              </a:ext>
            </a:extLst>
          </p:cNvPr>
          <p:cNvSpPr txBox="1"/>
          <p:nvPr/>
        </p:nvSpPr>
        <p:spPr>
          <a:xfrm>
            <a:off x="6457949" y="3752849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049   052   054   055   056   058   059   060   061   06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660D2A-3EA0-4825-87F1-8180788DCAC7}"/>
              </a:ext>
            </a:extLst>
          </p:cNvPr>
          <p:cNvSpPr txBox="1"/>
          <p:nvPr/>
        </p:nvSpPr>
        <p:spPr>
          <a:xfrm>
            <a:off x="5326237" y="53741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RRK2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018053FC-2E6D-449E-A718-F083E91B1A6E}"/>
              </a:ext>
            </a:extLst>
          </p:cNvPr>
          <p:cNvGrpSpPr/>
          <p:nvPr/>
        </p:nvGrpSpPr>
        <p:grpSpPr>
          <a:xfrm>
            <a:off x="811367" y="2098476"/>
            <a:ext cx="4355841" cy="1210011"/>
            <a:chOff x="811367" y="2098476"/>
            <a:chExt cx="4355841" cy="1210011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60995A41-4707-4D6A-A360-039B20A38F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665" r="5322" b="39684"/>
            <a:stretch/>
          </p:blipFill>
          <p:spPr>
            <a:xfrm>
              <a:off x="838200" y="2105597"/>
              <a:ext cx="4329008" cy="120289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8588D05-479F-480B-80CE-92582F151F67}"/>
                </a:ext>
              </a:extLst>
            </p:cNvPr>
            <p:cNvSpPr txBox="1"/>
            <p:nvPr/>
          </p:nvSpPr>
          <p:spPr>
            <a:xfrm>
              <a:off x="811367" y="209847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1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DAD59357-D14F-4541-9030-09CD282171F0}"/>
              </a:ext>
            </a:extLst>
          </p:cNvPr>
          <p:cNvGrpSpPr/>
          <p:nvPr/>
        </p:nvGrpSpPr>
        <p:grpSpPr>
          <a:xfrm>
            <a:off x="811367" y="4060625"/>
            <a:ext cx="4355841" cy="1197671"/>
            <a:chOff x="811367" y="4060625"/>
            <a:chExt cx="4355841" cy="1197671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459C275F-43EC-430D-85AB-4D63EB525E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846" r="8353" b="40098"/>
            <a:stretch/>
          </p:blipFill>
          <p:spPr>
            <a:xfrm>
              <a:off x="838200" y="4060626"/>
              <a:ext cx="4329008" cy="1197670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E1B85DE-ECA2-4237-9E98-B8119FC968CB}"/>
                </a:ext>
              </a:extLst>
            </p:cNvPr>
            <p:cNvSpPr txBox="1"/>
            <p:nvPr/>
          </p:nvSpPr>
          <p:spPr>
            <a:xfrm>
              <a:off x="811367" y="406062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2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2C9EC394-C189-4B14-9A68-196BCC048CD5}"/>
              </a:ext>
            </a:extLst>
          </p:cNvPr>
          <p:cNvGrpSpPr/>
          <p:nvPr/>
        </p:nvGrpSpPr>
        <p:grpSpPr>
          <a:xfrm>
            <a:off x="6373447" y="2098476"/>
            <a:ext cx="4329008" cy="1210011"/>
            <a:chOff x="6373447" y="2098476"/>
            <a:chExt cx="4329008" cy="1210011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6EE664D7-1570-41B3-AB22-EB24956184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460" t="7551" r="13223" b="33081"/>
            <a:stretch/>
          </p:blipFill>
          <p:spPr>
            <a:xfrm>
              <a:off x="6373447" y="2098477"/>
              <a:ext cx="4329008" cy="1210010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34730BD-07D9-4B1F-9520-355C81C1D269}"/>
                </a:ext>
              </a:extLst>
            </p:cNvPr>
            <p:cNvSpPr txBox="1"/>
            <p:nvPr/>
          </p:nvSpPr>
          <p:spPr>
            <a:xfrm>
              <a:off x="6373447" y="209847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3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BC604819-35D5-4FFC-AF90-E0426F173C9B}"/>
              </a:ext>
            </a:extLst>
          </p:cNvPr>
          <p:cNvGrpSpPr/>
          <p:nvPr/>
        </p:nvGrpSpPr>
        <p:grpSpPr>
          <a:xfrm>
            <a:off x="6373447" y="4048285"/>
            <a:ext cx="4341321" cy="1210011"/>
            <a:chOff x="6373447" y="4048285"/>
            <a:chExt cx="4341321" cy="1210011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417CD512-AE90-4EA4-8806-DE43EB9260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276" t="2015" r="12960" b="37560"/>
            <a:stretch/>
          </p:blipFill>
          <p:spPr>
            <a:xfrm>
              <a:off x="6385760" y="4048285"/>
              <a:ext cx="4329008" cy="1210011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6767285-5AB3-477E-BCBA-5323A1C1B3E3}"/>
                </a:ext>
              </a:extLst>
            </p:cNvPr>
            <p:cNvSpPr txBox="1"/>
            <p:nvPr/>
          </p:nvSpPr>
          <p:spPr>
            <a:xfrm>
              <a:off x="6373447" y="404828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4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78F75C6-AA07-29FC-F82C-F3647382CE79}"/>
              </a:ext>
            </a:extLst>
          </p:cNvPr>
          <p:cNvSpPr txBox="1"/>
          <p:nvPr/>
        </p:nvSpPr>
        <p:spPr>
          <a:xfrm>
            <a:off x="2956301" y="5884452"/>
            <a:ext cx="62793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LRRK2 (clone MJFF2 (c41-2); Abcam) at 1;1,000 rati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CBAECA4-0073-847D-F689-D59F988F3BF0}"/>
              </a:ext>
            </a:extLst>
          </p:cNvPr>
          <p:cNvSpPr txBox="1"/>
          <p:nvPr/>
        </p:nvSpPr>
        <p:spPr>
          <a:xfrm>
            <a:off x="2367642" y="6316261"/>
            <a:ext cx="9043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</p:spTree>
    <p:extLst>
      <p:ext uri="{BB962C8B-B14F-4D97-AF65-F5344CB8AC3E}">
        <p14:creationId xmlns:p14="http://schemas.microsoft.com/office/powerpoint/2010/main" val="102408468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FC4B33D-B1CF-48BE-B68B-3029611EB091}"/>
              </a:ext>
            </a:extLst>
          </p:cNvPr>
          <p:cNvSpPr txBox="1"/>
          <p:nvPr/>
        </p:nvSpPr>
        <p:spPr>
          <a:xfrm>
            <a:off x="902870" y="1790700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063   064   066   067   068   071   072   073   074   076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70B7130-E6B3-49C2-96A1-C2DC3F2F02E8}"/>
              </a:ext>
            </a:extLst>
          </p:cNvPr>
          <p:cNvSpPr txBox="1"/>
          <p:nvPr/>
        </p:nvSpPr>
        <p:spPr>
          <a:xfrm>
            <a:off x="902870" y="3752850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 077   078   079   081   082   083   084   085   089   09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700DFB7-B2B1-4F3B-8946-B745487AC553}"/>
              </a:ext>
            </a:extLst>
          </p:cNvPr>
          <p:cNvSpPr txBox="1"/>
          <p:nvPr/>
        </p:nvSpPr>
        <p:spPr>
          <a:xfrm>
            <a:off x="6353676" y="1790700"/>
            <a:ext cx="46987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 094   097   099   101   102   103   104   105   107   108   109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8C4B0D3-259E-4229-8174-85CC90966600}"/>
              </a:ext>
            </a:extLst>
          </p:cNvPr>
          <p:cNvSpPr txBox="1"/>
          <p:nvPr/>
        </p:nvSpPr>
        <p:spPr>
          <a:xfrm>
            <a:off x="6377739" y="3752849"/>
            <a:ext cx="46987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113   114   115   120   121   123   206   207   208   209   21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924C032-CC8C-451E-9ABF-E3EB315440A6}"/>
              </a:ext>
            </a:extLst>
          </p:cNvPr>
          <p:cNvSpPr txBox="1"/>
          <p:nvPr/>
        </p:nvSpPr>
        <p:spPr>
          <a:xfrm>
            <a:off x="5326237" y="53741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RRK2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B85AF3E-3657-43FC-96BE-4585D5B64C80}"/>
              </a:ext>
            </a:extLst>
          </p:cNvPr>
          <p:cNvGrpSpPr/>
          <p:nvPr/>
        </p:nvGrpSpPr>
        <p:grpSpPr>
          <a:xfrm>
            <a:off x="844590" y="2098474"/>
            <a:ext cx="4335890" cy="1202891"/>
            <a:chOff x="844590" y="2098474"/>
            <a:chExt cx="4335890" cy="1202891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5D0ECAD0-4C9C-4A2B-9C31-04D0F89B89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542" t="2945" r="6654" b="37683"/>
            <a:stretch/>
          </p:blipFill>
          <p:spPr>
            <a:xfrm>
              <a:off x="851472" y="2098475"/>
              <a:ext cx="4329008" cy="1202890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E4CFF47-2E05-44CB-A991-A3734FF9AB27}"/>
                </a:ext>
              </a:extLst>
            </p:cNvPr>
            <p:cNvSpPr txBox="1"/>
            <p:nvPr/>
          </p:nvSpPr>
          <p:spPr>
            <a:xfrm>
              <a:off x="844590" y="209847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5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83D77545-91FD-4D57-99F5-FE266F7815FC}"/>
              </a:ext>
            </a:extLst>
          </p:cNvPr>
          <p:cNvGrpSpPr/>
          <p:nvPr/>
        </p:nvGrpSpPr>
        <p:grpSpPr>
          <a:xfrm>
            <a:off x="844590" y="4060624"/>
            <a:ext cx="4342772" cy="1202891"/>
            <a:chOff x="844590" y="4060624"/>
            <a:chExt cx="4342772" cy="1202891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B7725DFD-377C-466B-9615-5081D224C8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0724" t="6094" r="7405" b="34578"/>
            <a:stretch/>
          </p:blipFill>
          <p:spPr>
            <a:xfrm>
              <a:off x="851472" y="4060625"/>
              <a:ext cx="4335890" cy="120289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292ED06-CF47-42B9-B1E5-098FCA986F24}"/>
                </a:ext>
              </a:extLst>
            </p:cNvPr>
            <p:cNvSpPr txBox="1"/>
            <p:nvPr/>
          </p:nvSpPr>
          <p:spPr>
            <a:xfrm>
              <a:off x="844590" y="406062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6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513E9F41-68EE-408D-9B3B-0DA450CC37BF}"/>
              </a:ext>
            </a:extLst>
          </p:cNvPr>
          <p:cNvGrpSpPr/>
          <p:nvPr/>
        </p:nvGrpSpPr>
        <p:grpSpPr>
          <a:xfrm>
            <a:off x="6312265" y="2098474"/>
            <a:ext cx="4764256" cy="1202891"/>
            <a:chOff x="6312265" y="2098474"/>
            <a:chExt cx="4764256" cy="1202891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123FE4DA-DC5D-4376-ACDA-2A1F63A3DA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224" t="12156" r="6983" b="35898"/>
            <a:stretch/>
          </p:blipFill>
          <p:spPr>
            <a:xfrm>
              <a:off x="6312265" y="2098474"/>
              <a:ext cx="4764256" cy="1202891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A125A68-942E-467C-AF3C-B7B211CDF1DF}"/>
                </a:ext>
              </a:extLst>
            </p:cNvPr>
            <p:cNvSpPr txBox="1"/>
            <p:nvPr/>
          </p:nvSpPr>
          <p:spPr>
            <a:xfrm>
              <a:off x="6312265" y="2129252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7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AE4ABA6A-A215-4DB3-9D1C-4EDD4AC75534}"/>
              </a:ext>
            </a:extLst>
          </p:cNvPr>
          <p:cNvGrpSpPr/>
          <p:nvPr/>
        </p:nvGrpSpPr>
        <p:grpSpPr>
          <a:xfrm>
            <a:off x="6312265" y="4060624"/>
            <a:ext cx="4759702" cy="1202891"/>
            <a:chOff x="6312265" y="4060624"/>
            <a:chExt cx="4759702" cy="1202891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F0BE47F4-BBB9-45DB-9AED-BEBF987638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907" t="6680" r="7406" b="40808"/>
            <a:stretch/>
          </p:blipFill>
          <p:spPr>
            <a:xfrm>
              <a:off x="6312265" y="4060624"/>
              <a:ext cx="4759702" cy="1202891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F068B1F-1E4D-41D3-92D3-A7EB2C60B006}"/>
                </a:ext>
              </a:extLst>
            </p:cNvPr>
            <p:cNvSpPr txBox="1"/>
            <p:nvPr/>
          </p:nvSpPr>
          <p:spPr>
            <a:xfrm>
              <a:off x="6332733" y="406062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8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70BF7FA3-33E4-C406-E4CC-90ECC972DB91}"/>
              </a:ext>
            </a:extLst>
          </p:cNvPr>
          <p:cNvSpPr txBox="1"/>
          <p:nvPr/>
        </p:nvSpPr>
        <p:spPr>
          <a:xfrm>
            <a:off x="2367642" y="6316261"/>
            <a:ext cx="9043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179EE33-EDBD-D3FF-5FC8-0C55D97D7789}"/>
              </a:ext>
            </a:extLst>
          </p:cNvPr>
          <p:cNvSpPr txBox="1"/>
          <p:nvPr/>
        </p:nvSpPr>
        <p:spPr>
          <a:xfrm>
            <a:off x="2956301" y="5884452"/>
            <a:ext cx="62793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LRRK2 (clone MJFF2 (c41-2); Abcam) at 1;1,000 ratio</a:t>
            </a:r>
          </a:p>
        </p:txBody>
      </p:sp>
    </p:spTree>
    <p:extLst>
      <p:ext uri="{BB962C8B-B14F-4D97-AF65-F5344CB8AC3E}">
        <p14:creationId xmlns:p14="http://schemas.microsoft.com/office/powerpoint/2010/main" val="122326315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C37EAAE-BFA2-4FA5-B5A6-BE25A8E068C7}"/>
              </a:ext>
            </a:extLst>
          </p:cNvPr>
          <p:cNvSpPr txBox="1"/>
          <p:nvPr/>
        </p:nvSpPr>
        <p:spPr>
          <a:xfrm>
            <a:off x="910891" y="1790700"/>
            <a:ext cx="4224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001   003   005   006   008   009   010   011   012   01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8AF64D6-DA11-4924-8E46-AC0ABD511AED}"/>
              </a:ext>
            </a:extLst>
          </p:cNvPr>
          <p:cNvSpPr txBox="1"/>
          <p:nvPr/>
        </p:nvSpPr>
        <p:spPr>
          <a:xfrm>
            <a:off x="918912" y="3752850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015   016   019   021   023   024   025   026   027   02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986EAB-C66A-4717-B748-A234CC1F85E1}"/>
              </a:ext>
            </a:extLst>
          </p:cNvPr>
          <p:cNvSpPr txBox="1"/>
          <p:nvPr/>
        </p:nvSpPr>
        <p:spPr>
          <a:xfrm>
            <a:off x="6465970" y="1790700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029   031   036   039   041   042   043   044   045   048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DE973B-38EA-4A51-B4AD-C3C519D74398}"/>
              </a:ext>
            </a:extLst>
          </p:cNvPr>
          <p:cNvSpPr txBox="1"/>
          <p:nvPr/>
        </p:nvSpPr>
        <p:spPr>
          <a:xfrm>
            <a:off x="6457949" y="3752849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049   052   054   055   056   058   059   060   061   062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23FCE643-F267-4A96-8752-BBB88D5A6051}"/>
              </a:ext>
            </a:extLst>
          </p:cNvPr>
          <p:cNvGrpSpPr/>
          <p:nvPr/>
        </p:nvGrpSpPr>
        <p:grpSpPr>
          <a:xfrm>
            <a:off x="6401862" y="4060625"/>
            <a:ext cx="4362120" cy="908588"/>
            <a:chOff x="6401862" y="4060625"/>
            <a:chExt cx="4362120" cy="908588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B56E9E08-8382-43D0-A0A3-1B90220711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47" t="53810" r="2917" b="6687"/>
            <a:stretch/>
          </p:blipFill>
          <p:spPr>
            <a:xfrm>
              <a:off x="6409705" y="4060625"/>
              <a:ext cx="4354277" cy="908588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F2AADBE-B409-4F83-9EBE-739A2C8DDE37}"/>
                </a:ext>
              </a:extLst>
            </p:cNvPr>
            <p:cNvSpPr txBox="1"/>
            <p:nvPr/>
          </p:nvSpPr>
          <p:spPr>
            <a:xfrm>
              <a:off x="6401862" y="406062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4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B211ACA8-05CA-4F83-83CC-B154DEF1EA8E}"/>
              </a:ext>
            </a:extLst>
          </p:cNvPr>
          <p:cNvGrpSpPr/>
          <p:nvPr/>
        </p:nvGrpSpPr>
        <p:grpSpPr>
          <a:xfrm>
            <a:off x="6409705" y="2098476"/>
            <a:ext cx="4352627" cy="908588"/>
            <a:chOff x="6409705" y="2098476"/>
            <a:chExt cx="4352627" cy="908588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F45C778A-09E8-4E0C-98DE-773B27EA46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791" t="6736" r="3920" b="53413"/>
            <a:stretch/>
          </p:blipFill>
          <p:spPr>
            <a:xfrm>
              <a:off x="6409705" y="2098476"/>
              <a:ext cx="4352627" cy="908588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C657BBF-1917-4E24-A141-375F964C82DA}"/>
                </a:ext>
              </a:extLst>
            </p:cNvPr>
            <p:cNvSpPr txBox="1"/>
            <p:nvPr/>
          </p:nvSpPr>
          <p:spPr>
            <a:xfrm>
              <a:off x="6409705" y="210559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3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BB103536-ECE1-4172-BDFE-35E6D68BB899}"/>
              </a:ext>
            </a:extLst>
          </p:cNvPr>
          <p:cNvGrpSpPr/>
          <p:nvPr/>
        </p:nvGrpSpPr>
        <p:grpSpPr>
          <a:xfrm>
            <a:off x="894287" y="2097220"/>
            <a:ext cx="4329008" cy="928973"/>
            <a:chOff x="894287" y="2097220"/>
            <a:chExt cx="4329008" cy="928973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66E3A31A-1413-4BA8-91CA-83EF412C45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762" t="2677" r="2669" b="60104"/>
            <a:stretch/>
          </p:blipFill>
          <p:spPr>
            <a:xfrm>
              <a:off x="894287" y="2105597"/>
              <a:ext cx="4329008" cy="920596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55CC177-F9F6-4292-8F47-4130DF151DF4}"/>
                </a:ext>
              </a:extLst>
            </p:cNvPr>
            <p:cNvSpPr txBox="1"/>
            <p:nvPr/>
          </p:nvSpPr>
          <p:spPr>
            <a:xfrm>
              <a:off x="894287" y="209722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1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30493EDA-5769-41D8-9F94-BB372BBD251A}"/>
              </a:ext>
            </a:extLst>
          </p:cNvPr>
          <p:cNvGrpSpPr/>
          <p:nvPr/>
        </p:nvGrpSpPr>
        <p:grpSpPr>
          <a:xfrm>
            <a:off x="879429" y="4024701"/>
            <a:ext cx="4383349" cy="908588"/>
            <a:chOff x="879429" y="4024701"/>
            <a:chExt cx="4383349" cy="908588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3E23FB4D-7A68-4430-940E-D7895B7941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574" t="58446" r="2870" b="5156"/>
            <a:stretch/>
          </p:blipFill>
          <p:spPr>
            <a:xfrm>
              <a:off x="894287" y="4024701"/>
              <a:ext cx="4368491" cy="908588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00E6E0F-AAF4-4401-BAA1-AD5577849160}"/>
                </a:ext>
              </a:extLst>
            </p:cNvPr>
            <p:cNvSpPr txBox="1"/>
            <p:nvPr/>
          </p:nvSpPr>
          <p:spPr>
            <a:xfrm>
              <a:off x="879429" y="4024701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2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D67CA521-B443-4C94-A739-5465239A3B29}"/>
              </a:ext>
            </a:extLst>
          </p:cNvPr>
          <p:cNvSpPr txBox="1"/>
          <p:nvPr/>
        </p:nvSpPr>
        <p:spPr>
          <a:xfrm>
            <a:off x="4885079" y="573204"/>
            <a:ext cx="1589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RRK2-ps-129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1F8C03F-EC17-4FF5-E36F-4983AB1D1D2F}"/>
              </a:ext>
            </a:extLst>
          </p:cNvPr>
          <p:cNvSpPr txBox="1"/>
          <p:nvPr/>
        </p:nvSpPr>
        <p:spPr>
          <a:xfrm>
            <a:off x="2827441" y="5904563"/>
            <a:ext cx="71488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pSer1292-LRRK2 (clone MJFR-19-7-8; Abcam) at 1:500 rati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058C645-A3C4-EA2A-2CB7-D10F6130E325}"/>
              </a:ext>
            </a:extLst>
          </p:cNvPr>
          <p:cNvSpPr txBox="1"/>
          <p:nvPr/>
        </p:nvSpPr>
        <p:spPr>
          <a:xfrm>
            <a:off x="2367642" y="6316261"/>
            <a:ext cx="9043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</p:spTree>
    <p:extLst>
      <p:ext uri="{BB962C8B-B14F-4D97-AF65-F5344CB8AC3E}">
        <p14:creationId xmlns:p14="http://schemas.microsoft.com/office/powerpoint/2010/main" val="199624214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1A66C4C-147C-4D1E-B581-6C9970669201}"/>
              </a:ext>
            </a:extLst>
          </p:cNvPr>
          <p:cNvSpPr txBox="1"/>
          <p:nvPr/>
        </p:nvSpPr>
        <p:spPr>
          <a:xfrm>
            <a:off x="902870" y="1790700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063   064   066   067   068   071   072   073   074   07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8F9477-EC41-49C7-A578-C1AFA27942B4}"/>
              </a:ext>
            </a:extLst>
          </p:cNvPr>
          <p:cNvSpPr txBox="1"/>
          <p:nvPr/>
        </p:nvSpPr>
        <p:spPr>
          <a:xfrm>
            <a:off x="902870" y="3752850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 077   078   079   081   082   083   084   085   089   09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4475228-EB77-4A64-A722-F4506177779B}"/>
              </a:ext>
            </a:extLst>
          </p:cNvPr>
          <p:cNvSpPr txBox="1"/>
          <p:nvPr/>
        </p:nvSpPr>
        <p:spPr>
          <a:xfrm>
            <a:off x="6353676" y="1790700"/>
            <a:ext cx="43444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 094   097   099   101   102   103   104   105   107   108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0FE41B-EF7A-4098-B61A-173C79DEF963}"/>
              </a:ext>
            </a:extLst>
          </p:cNvPr>
          <p:cNvSpPr txBox="1"/>
          <p:nvPr/>
        </p:nvSpPr>
        <p:spPr>
          <a:xfrm>
            <a:off x="6377739" y="3752849"/>
            <a:ext cx="4304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  109   113   114   115   120   121   123   206   207   20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50AB6-8094-4243-AFDE-5CE668F067C8}"/>
              </a:ext>
            </a:extLst>
          </p:cNvPr>
          <p:cNvSpPr txBox="1"/>
          <p:nvPr/>
        </p:nvSpPr>
        <p:spPr>
          <a:xfrm>
            <a:off x="4885079" y="573204"/>
            <a:ext cx="1589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RRK2-ps-1292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79A79172-B598-4CE1-9768-F3D2DEC40006}"/>
              </a:ext>
            </a:extLst>
          </p:cNvPr>
          <p:cNvGrpSpPr/>
          <p:nvPr/>
        </p:nvGrpSpPr>
        <p:grpSpPr>
          <a:xfrm>
            <a:off x="892716" y="2098474"/>
            <a:ext cx="4346044" cy="903245"/>
            <a:chOff x="892716" y="2098474"/>
            <a:chExt cx="4346044" cy="90324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B7043B98-5C53-48B1-8DFD-D9B9AB12DC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661" t="24741" r="8722" b="13077"/>
            <a:stretch/>
          </p:blipFill>
          <p:spPr>
            <a:xfrm>
              <a:off x="902870" y="2098474"/>
              <a:ext cx="4335890" cy="903245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1088DED-29A6-4C27-B29D-9F2D1E329270}"/>
                </a:ext>
              </a:extLst>
            </p:cNvPr>
            <p:cNvSpPr txBox="1"/>
            <p:nvPr/>
          </p:nvSpPr>
          <p:spPr>
            <a:xfrm>
              <a:off x="892716" y="209847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5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5CA7A4C7-8FD4-4997-B4C6-A04111C540FA}"/>
              </a:ext>
            </a:extLst>
          </p:cNvPr>
          <p:cNvGrpSpPr/>
          <p:nvPr/>
        </p:nvGrpSpPr>
        <p:grpSpPr>
          <a:xfrm>
            <a:off x="828548" y="4065969"/>
            <a:ext cx="4378705" cy="903245"/>
            <a:chOff x="828548" y="4065969"/>
            <a:chExt cx="4378705" cy="903245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38CBCB10-57BB-4AA7-9B14-990B88A47E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927" t="14392" r="3816"/>
            <a:stretch/>
          </p:blipFill>
          <p:spPr>
            <a:xfrm>
              <a:off x="844590" y="4065969"/>
              <a:ext cx="4362663" cy="903245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EDA2506-4090-4E11-99E0-B40BB5669ACF}"/>
                </a:ext>
              </a:extLst>
            </p:cNvPr>
            <p:cNvSpPr txBox="1"/>
            <p:nvPr/>
          </p:nvSpPr>
          <p:spPr>
            <a:xfrm>
              <a:off x="828548" y="406781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6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C955C7CB-C2B5-4195-BBA6-365461686E7D}"/>
              </a:ext>
            </a:extLst>
          </p:cNvPr>
          <p:cNvGrpSpPr/>
          <p:nvPr/>
        </p:nvGrpSpPr>
        <p:grpSpPr>
          <a:xfrm>
            <a:off x="6307562" y="2089676"/>
            <a:ext cx="4335890" cy="912043"/>
            <a:chOff x="6307562" y="2089676"/>
            <a:chExt cx="4335890" cy="912043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813A7F92-7B06-482C-BF9D-FAB08CB5AA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0329" r="6114" b="61804"/>
            <a:stretch/>
          </p:blipFill>
          <p:spPr>
            <a:xfrm>
              <a:off x="6307562" y="2098474"/>
              <a:ext cx="4335890" cy="903245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CDC982D-82A4-47B0-B164-C379FA4ACB7D}"/>
                </a:ext>
              </a:extLst>
            </p:cNvPr>
            <p:cNvSpPr txBox="1"/>
            <p:nvPr/>
          </p:nvSpPr>
          <p:spPr>
            <a:xfrm>
              <a:off x="6307562" y="208967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7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D222BEF7-74EA-4B62-BDBD-FC91ED6EAF75}"/>
              </a:ext>
            </a:extLst>
          </p:cNvPr>
          <p:cNvGrpSpPr/>
          <p:nvPr/>
        </p:nvGrpSpPr>
        <p:grpSpPr>
          <a:xfrm>
            <a:off x="6307562" y="4067814"/>
            <a:ext cx="4335890" cy="901400"/>
            <a:chOff x="6307562" y="4067814"/>
            <a:chExt cx="4335890" cy="901400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361ACE96-BD34-4993-AFDF-2B86D254F3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224" t="55733" r="6447" b="5342"/>
            <a:stretch/>
          </p:blipFill>
          <p:spPr>
            <a:xfrm>
              <a:off x="6307562" y="4067814"/>
              <a:ext cx="4335890" cy="901400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C175B9D-F824-4BDF-8AA8-F04D6488FE65}"/>
                </a:ext>
              </a:extLst>
            </p:cNvPr>
            <p:cNvSpPr txBox="1"/>
            <p:nvPr/>
          </p:nvSpPr>
          <p:spPr>
            <a:xfrm>
              <a:off x="6307562" y="406781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8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D82EC254-1904-4B0A-9A15-39D0D2C6D480}"/>
              </a:ext>
            </a:extLst>
          </p:cNvPr>
          <p:cNvSpPr txBox="1"/>
          <p:nvPr/>
        </p:nvSpPr>
        <p:spPr>
          <a:xfrm>
            <a:off x="6323315" y="5532106"/>
            <a:ext cx="16257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          C     209   210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81A6A28-7E01-48FF-9233-E39F065C64AC}"/>
              </a:ext>
            </a:extLst>
          </p:cNvPr>
          <p:cNvGrpSpPr/>
          <p:nvPr/>
        </p:nvGrpSpPr>
        <p:grpSpPr>
          <a:xfrm>
            <a:off x="6274692" y="5834094"/>
            <a:ext cx="1674389" cy="901402"/>
            <a:chOff x="6274692" y="5834094"/>
            <a:chExt cx="1674389" cy="901402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6977C1A-82FC-4F7D-B1B9-264BFFCCBF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895" t="9835" r="16463" b="15726"/>
            <a:stretch/>
          </p:blipFill>
          <p:spPr>
            <a:xfrm>
              <a:off x="6274692" y="5834094"/>
              <a:ext cx="1674389" cy="901402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DDA0957-4FDC-4EA1-B17A-DFEE3304CF8C}"/>
                </a:ext>
              </a:extLst>
            </p:cNvPr>
            <p:cNvSpPr txBox="1"/>
            <p:nvPr/>
          </p:nvSpPr>
          <p:spPr>
            <a:xfrm>
              <a:off x="6274692" y="583409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9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CCEF08BD-8BF3-87FF-4807-FF290E4B6C02}"/>
              </a:ext>
            </a:extLst>
          </p:cNvPr>
          <p:cNvSpPr txBox="1"/>
          <p:nvPr/>
        </p:nvSpPr>
        <p:spPr>
          <a:xfrm>
            <a:off x="0" y="5947599"/>
            <a:ext cx="581297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BE3B36-0B4B-3769-B14E-0BA5E61684C5}"/>
              </a:ext>
            </a:extLst>
          </p:cNvPr>
          <p:cNvSpPr txBox="1"/>
          <p:nvPr/>
        </p:nvSpPr>
        <p:spPr>
          <a:xfrm>
            <a:off x="0" y="521386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pSer1292-LRRK2 (clone MJFR-19-7-8; Abcam) at 1:500 ratio</a:t>
            </a:r>
          </a:p>
        </p:txBody>
      </p:sp>
    </p:spTree>
    <p:extLst>
      <p:ext uri="{BB962C8B-B14F-4D97-AF65-F5344CB8AC3E}">
        <p14:creationId xmlns:p14="http://schemas.microsoft.com/office/powerpoint/2010/main" val="2924229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clock, shelf&#10;&#10;Description automatically generated">
            <a:extLst>
              <a:ext uri="{FF2B5EF4-FFF2-40B4-BE49-F238E27FC236}">
                <a16:creationId xmlns:a16="http://schemas.microsoft.com/office/drawing/2014/main" id="{E9BF1218-8780-5330-C1DD-791B78BF9CF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613"/>
          <a:stretch/>
        </p:blipFill>
        <p:spPr>
          <a:xfrm>
            <a:off x="4272302" y="1142589"/>
            <a:ext cx="7446851" cy="275335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BAAB149-0BBE-679C-49FF-332370BDC3C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3" t="73898" r="10248"/>
          <a:stretch/>
        </p:blipFill>
        <p:spPr bwMode="auto">
          <a:xfrm>
            <a:off x="4597236" y="4024032"/>
            <a:ext cx="5871711" cy="1687009"/>
          </a:xfrm>
          <a:prstGeom prst="rect">
            <a:avLst/>
          </a:prstGeom>
          <a:noFill/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BF629C8-C8CB-DFE9-1168-7C54A57B4B86}"/>
              </a:ext>
            </a:extLst>
          </p:cNvPr>
          <p:cNvSpPr txBox="1"/>
          <p:nvPr/>
        </p:nvSpPr>
        <p:spPr>
          <a:xfrm>
            <a:off x="100304" y="5025144"/>
            <a:ext cx="404906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LRRK2 (clone MJFF2 (c41-2); Abcam) at 1;1,000 ratio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9F3488-1F62-B494-18A4-09F0CFC29A6C}"/>
              </a:ext>
            </a:extLst>
          </p:cNvPr>
          <p:cNvSpPr txBox="1"/>
          <p:nvPr/>
        </p:nvSpPr>
        <p:spPr>
          <a:xfrm>
            <a:off x="100304" y="2059546"/>
            <a:ext cx="404906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CD9 (clone D3H4P; Cell Signaling Technology) at 1:5,000 ratio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7EEDBC4D-7CF4-10A7-5A78-29B7D11E9E3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3" t="44547" b="44934"/>
          <a:stretch/>
        </p:blipFill>
        <p:spPr bwMode="auto">
          <a:xfrm>
            <a:off x="4749281" y="357073"/>
            <a:ext cx="6312735" cy="657425"/>
          </a:xfrm>
          <a:prstGeom prst="rect">
            <a:avLst/>
          </a:prstGeom>
          <a:noFill/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BF8D5566-341C-0B92-9DCF-A2AE5629989C}"/>
              </a:ext>
            </a:extLst>
          </p:cNvPr>
          <p:cNvSpPr txBox="1"/>
          <p:nvPr/>
        </p:nvSpPr>
        <p:spPr>
          <a:xfrm>
            <a:off x="2367642" y="6316261"/>
            <a:ext cx="9043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</p:spTree>
    <p:extLst>
      <p:ext uri="{BB962C8B-B14F-4D97-AF65-F5344CB8AC3E}">
        <p14:creationId xmlns:p14="http://schemas.microsoft.com/office/powerpoint/2010/main" val="17380824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EFCEE1-3374-7407-C280-D83587123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47785" y="2604472"/>
            <a:ext cx="11096430" cy="1325563"/>
          </a:xfrm>
        </p:spPr>
        <p:txBody>
          <a:bodyPr>
            <a:normAutofit fontScale="90000"/>
          </a:bodyPr>
          <a:lstStyle/>
          <a:p>
            <a:pPr algn="ctr"/>
            <a:b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ry Figure 10a</a:t>
            </a:r>
            <a:b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b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lang="en-US" sz="18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All 20 urine EV samples were analyzed by Western Blot with anti-CD9, or anti-STK11, or anti-PCSK1N together with anti-HNRNPA1 antibodies (2 blots for each type). An equal amount of pooled urine EVs was loaded in lane 1 of each gel. </a:t>
            </a:r>
            <a:b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76349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 with medium confidence">
            <a:extLst>
              <a:ext uri="{FF2B5EF4-FFF2-40B4-BE49-F238E27FC236}">
                <a16:creationId xmlns:a16="http://schemas.microsoft.com/office/drawing/2014/main" id="{37319CE7-46C9-53D3-BD04-28667092AF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3877" y="1341013"/>
            <a:ext cx="7095410" cy="516931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D426742-7B01-207A-02F9-3F4D6D2A2DBB}"/>
              </a:ext>
            </a:extLst>
          </p:cNvPr>
          <p:cNvSpPr txBox="1"/>
          <p:nvPr/>
        </p:nvSpPr>
        <p:spPr>
          <a:xfrm>
            <a:off x="174999" y="1846203"/>
            <a:ext cx="42850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STK11 (clone D60C5; Cell Signaling Technology) at 1:1,000 rati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BF7EB0E-76C1-B51F-BF65-7B66EEA5DE48}"/>
              </a:ext>
            </a:extLst>
          </p:cNvPr>
          <p:cNvSpPr txBox="1"/>
          <p:nvPr/>
        </p:nvSpPr>
        <p:spPr>
          <a:xfrm>
            <a:off x="174999" y="3925669"/>
            <a:ext cx="404906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CD9 (clone D3H4P; Cell Signaling Technology) at 1:5,000 ratio</a:t>
            </a:r>
          </a:p>
        </p:txBody>
      </p:sp>
      <p:pic>
        <p:nvPicPr>
          <p:cNvPr id="10" name="Picture 9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F0D766AF-CC29-98F7-35EF-5529D3DACF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446" r="10254" b="90429"/>
          <a:stretch/>
        </p:blipFill>
        <p:spPr>
          <a:xfrm>
            <a:off x="5151119" y="553781"/>
            <a:ext cx="6502815" cy="69904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CACFE0B-3B9D-D45F-A14C-6226F104BEBE}"/>
              </a:ext>
            </a:extLst>
          </p:cNvPr>
          <p:cNvSpPr txBox="1"/>
          <p:nvPr/>
        </p:nvSpPr>
        <p:spPr>
          <a:xfrm>
            <a:off x="128346" y="5848010"/>
            <a:ext cx="43783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</p:spTree>
    <p:extLst>
      <p:ext uri="{BB962C8B-B14F-4D97-AF65-F5344CB8AC3E}">
        <p14:creationId xmlns:p14="http://schemas.microsoft.com/office/powerpoint/2010/main" val="11668647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D426742-7B01-207A-02F9-3F4D6D2A2DBB}"/>
              </a:ext>
            </a:extLst>
          </p:cNvPr>
          <p:cNvSpPr txBox="1"/>
          <p:nvPr/>
        </p:nvSpPr>
        <p:spPr>
          <a:xfrm>
            <a:off x="174999" y="1846203"/>
            <a:ext cx="42850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STK11 (clone D60C5; Cell Signaling Technology) at 1:1,000 rati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BF7EB0E-76C1-B51F-BF65-7B66EEA5DE48}"/>
              </a:ext>
            </a:extLst>
          </p:cNvPr>
          <p:cNvSpPr txBox="1"/>
          <p:nvPr/>
        </p:nvSpPr>
        <p:spPr>
          <a:xfrm>
            <a:off x="174999" y="3925669"/>
            <a:ext cx="404906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CD9 (clone D3H4P; Cell Signaling Technology) at 1:5,000 ratio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A4AF7027-C2E6-2327-B943-03DAFEBC04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0033" y="1498586"/>
            <a:ext cx="7095411" cy="5140988"/>
          </a:xfrm>
          <a:prstGeom prst="rect">
            <a:avLst/>
          </a:prstGeom>
        </p:spPr>
      </p:pic>
      <p:pic>
        <p:nvPicPr>
          <p:cNvPr id="6" name="Picture 5" descr="Graphical user interface&#10;&#10;Description automatically generated">
            <a:extLst>
              <a:ext uri="{FF2B5EF4-FFF2-40B4-BE49-F238E27FC236}">
                <a16:creationId xmlns:a16="http://schemas.microsoft.com/office/drawing/2014/main" id="{65F5198F-2BF8-9904-DF4F-7E771AA226E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570" r="11944" b="90456"/>
          <a:stretch/>
        </p:blipFill>
        <p:spPr>
          <a:xfrm>
            <a:off x="5063878" y="653143"/>
            <a:ext cx="6193178" cy="67986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B90EDD3-6277-55D9-8756-BE0D34816426}"/>
              </a:ext>
            </a:extLst>
          </p:cNvPr>
          <p:cNvSpPr txBox="1"/>
          <p:nvPr/>
        </p:nvSpPr>
        <p:spPr>
          <a:xfrm>
            <a:off x="128346" y="5848010"/>
            <a:ext cx="43783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</p:spTree>
    <p:extLst>
      <p:ext uri="{BB962C8B-B14F-4D97-AF65-F5344CB8AC3E}">
        <p14:creationId xmlns:p14="http://schemas.microsoft.com/office/powerpoint/2010/main" val="14558683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close up of a keyboard&#10;&#10;Description automatically generated with low confidence">
            <a:extLst>
              <a:ext uri="{FF2B5EF4-FFF2-40B4-BE49-F238E27FC236}">
                <a16:creationId xmlns:a16="http://schemas.microsoft.com/office/drawing/2014/main" id="{AB14C72D-DB41-9688-7781-CF402539102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3636"/>
          <a:stretch/>
        </p:blipFill>
        <p:spPr>
          <a:xfrm>
            <a:off x="4531771" y="898317"/>
            <a:ext cx="7013452" cy="243876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74A487C-D18D-A058-C189-EC2973799770}"/>
              </a:ext>
            </a:extLst>
          </p:cNvPr>
          <p:cNvSpPr txBox="1"/>
          <p:nvPr/>
        </p:nvSpPr>
        <p:spPr>
          <a:xfrm>
            <a:off x="296297" y="2900561"/>
            <a:ext cx="376251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HNRNPA1 (clone D21H11; Cell Signaling Technology) at 1:1,000 ratio</a:t>
            </a:r>
          </a:p>
        </p:txBody>
      </p:sp>
      <p:pic>
        <p:nvPicPr>
          <p:cNvPr id="11" name="Picture 10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E055D3E8-2407-B4A0-125F-0CBAC10725E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446" r="10254" b="90429"/>
          <a:stretch/>
        </p:blipFill>
        <p:spPr>
          <a:xfrm>
            <a:off x="4866337" y="130247"/>
            <a:ext cx="6502815" cy="699040"/>
          </a:xfrm>
          <a:prstGeom prst="rect">
            <a:avLst/>
          </a:prstGeom>
        </p:spPr>
      </p:pic>
      <p:pic>
        <p:nvPicPr>
          <p:cNvPr id="12" name="Picture 11" descr="A close up of a keyboard&#10;&#10;Description automatically generated with low confidence">
            <a:extLst>
              <a:ext uri="{FF2B5EF4-FFF2-40B4-BE49-F238E27FC236}">
                <a16:creationId xmlns:a16="http://schemas.microsoft.com/office/drawing/2014/main" id="{0BB0962F-2ADF-6200-28B3-B040F98B94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6896"/>
          <a:stretch/>
        </p:blipFill>
        <p:spPr>
          <a:xfrm>
            <a:off x="4531771" y="4064669"/>
            <a:ext cx="7013452" cy="2793331"/>
          </a:xfrm>
          <a:prstGeom prst="rect">
            <a:avLst/>
          </a:prstGeom>
        </p:spPr>
      </p:pic>
      <p:pic>
        <p:nvPicPr>
          <p:cNvPr id="13" name="Picture 12" descr="Graphical user interface&#10;&#10;Description automatically generated">
            <a:extLst>
              <a:ext uri="{FF2B5EF4-FFF2-40B4-BE49-F238E27FC236}">
                <a16:creationId xmlns:a16="http://schemas.microsoft.com/office/drawing/2014/main" id="{31E0AB41-6CFF-9E29-389E-E9047BDF0CD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570" r="11944" b="90456"/>
          <a:stretch/>
        </p:blipFill>
        <p:spPr>
          <a:xfrm>
            <a:off x="5182461" y="3337084"/>
            <a:ext cx="5999061" cy="65855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8BA0ECF-809B-9DA0-4465-50AF04580A78}"/>
              </a:ext>
            </a:extLst>
          </p:cNvPr>
          <p:cNvSpPr txBox="1"/>
          <p:nvPr/>
        </p:nvSpPr>
        <p:spPr>
          <a:xfrm>
            <a:off x="128346" y="5848010"/>
            <a:ext cx="43783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</p:spTree>
    <p:extLst>
      <p:ext uri="{BB962C8B-B14F-4D97-AF65-F5344CB8AC3E}">
        <p14:creationId xmlns:p14="http://schemas.microsoft.com/office/powerpoint/2010/main" val="17643081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close&#10;&#10;Description automatically generated">
            <a:extLst>
              <a:ext uri="{FF2B5EF4-FFF2-40B4-BE49-F238E27FC236}">
                <a16:creationId xmlns:a16="http://schemas.microsoft.com/office/drawing/2014/main" id="{698D8881-2589-4DF2-64AD-1D9E7D00BD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3900"/>
          <a:stretch/>
        </p:blipFill>
        <p:spPr>
          <a:xfrm>
            <a:off x="4408908" y="699040"/>
            <a:ext cx="7181130" cy="248290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D0895F6-00DD-F621-6502-D42D9FC0A9E0}"/>
              </a:ext>
            </a:extLst>
          </p:cNvPr>
          <p:cNvSpPr txBox="1"/>
          <p:nvPr/>
        </p:nvSpPr>
        <p:spPr>
          <a:xfrm>
            <a:off x="370942" y="2782668"/>
            <a:ext cx="357590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mouse anti-PCSK1N (clone NP_037403.1; Millipore-Sigma) at 1:1,000 ratio</a:t>
            </a:r>
          </a:p>
        </p:txBody>
      </p:sp>
      <p:pic>
        <p:nvPicPr>
          <p:cNvPr id="8" name="Picture 7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03C5F380-0CE1-C79D-55C8-304F6A7B116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446" r="10254" b="90429"/>
          <a:stretch/>
        </p:blipFill>
        <p:spPr>
          <a:xfrm>
            <a:off x="4866337" y="0"/>
            <a:ext cx="6502815" cy="699040"/>
          </a:xfrm>
          <a:prstGeom prst="rect">
            <a:avLst/>
          </a:prstGeom>
        </p:spPr>
      </p:pic>
      <p:pic>
        <p:nvPicPr>
          <p:cNvPr id="9" name="Picture 8" descr="A picture containing text, close&#10;&#10;Description automatically generated">
            <a:extLst>
              <a:ext uri="{FF2B5EF4-FFF2-40B4-BE49-F238E27FC236}">
                <a16:creationId xmlns:a16="http://schemas.microsoft.com/office/drawing/2014/main" id="{8551A6FE-26B1-643A-7191-FD0E17346A8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6100"/>
          <a:stretch/>
        </p:blipFill>
        <p:spPr>
          <a:xfrm>
            <a:off x="4408908" y="3880985"/>
            <a:ext cx="7181130" cy="2902944"/>
          </a:xfrm>
          <a:prstGeom prst="rect">
            <a:avLst/>
          </a:prstGeom>
        </p:spPr>
      </p:pic>
      <p:pic>
        <p:nvPicPr>
          <p:cNvPr id="10" name="Picture 9" descr="Graphical user interface&#10;&#10;Description automatically generated">
            <a:extLst>
              <a:ext uri="{FF2B5EF4-FFF2-40B4-BE49-F238E27FC236}">
                <a16:creationId xmlns:a16="http://schemas.microsoft.com/office/drawing/2014/main" id="{848688BF-A935-FF88-E77B-E466F706FFC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570" r="11944" b="90456"/>
          <a:stretch/>
        </p:blipFill>
        <p:spPr>
          <a:xfrm>
            <a:off x="4997136" y="3181945"/>
            <a:ext cx="6241215" cy="68513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2060922-4EB8-F3AF-A82A-590F782B9154}"/>
              </a:ext>
            </a:extLst>
          </p:cNvPr>
          <p:cNvSpPr txBox="1"/>
          <p:nvPr/>
        </p:nvSpPr>
        <p:spPr>
          <a:xfrm>
            <a:off x="128346" y="5848010"/>
            <a:ext cx="43783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Mouse Alexa-Fluor 800 nm (Thermo Fisher Scientific) </a:t>
            </a:r>
            <a:endParaRPr lang="en-US" dirty="0">
              <a:latin typeface="Calibri (Body)"/>
            </a:endParaRPr>
          </a:p>
        </p:txBody>
      </p:sp>
    </p:spTree>
    <p:extLst>
      <p:ext uri="{BB962C8B-B14F-4D97-AF65-F5344CB8AC3E}">
        <p14:creationId xmlns:p14="http://schemas.microsoft.com/office/powerpoint/2010/main" val="35657877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EFCEE1-3374-7407-C280-D83587123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0141" y="2604472"/>
            <a:ext cx="10871718" cy="1325563"/>
          </a:xfrm>
        </p:spPr>
        <p:txBody>
          <a:bodyPr>
            <a:normAutofit fontScale="90000"/>
          </a:bodyPr>
          <a:lstStyle/>
          <a:p>
            <a:pPr algn="ctr"/>
            <a:b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ry Figure 11a</a:t>
            </a:r>
            <a:b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br>
              <a:rPr lang="en-US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lang="en-US" sz="18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All 82 urine EV samples were analyzed by Western Blot with anti-CD9, anti-LRRK2, and anti-pSer1292-LRRK2 antibodies (8 blots for each type). An equal amount of a spike-in standard was loaded in lane 1 of each gel (pooled urine EVs for CD9 blots, recombinant LRRK2 for LRRK2 blots, and </a:t>
            </a:r>
            <a:r>
              <a:rPr lang="en-US" sz="1800" dirty="0" err="1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autophosphorylated</a:t>
            </a:r>
            <a:r>
              <a:rPr lang="en-US" sz="18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recombinant LRRK2 for pSer1292-LRRK2 blots).</a:t>
            </a:r>
            <a:b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85574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01B5112-C81A-446A-9027-50F9F8101B81}"/>
              </a:ext>
            </a:extLst>
          </p:cNvPr>
          <p:cNvSpPr txBox="1"/>
          <p:nvPr/>
        </p:nvSpPr>
        <p:spPr>
          <a:xfrm>
            <a:off x="942975" y="1790700"/>
            <a:ext cx="4224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001   003   005   006   008   009   010   011   012   01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7471F79-BAED-4401-A4A5-6714B7E96B3A}"/>
              </a:ext>
            </a:extLst>
          </p:cNvPr>
          <p:cNvSpPr txBox="1"/>
          <p:nvPr/>
        </p:nvSpPr>
        <p:spPr>
          <a:xfrm>
            <a:off x="942975" y="3752850"/>
            <a:ext cx="4224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015   016   019   021   023   024   025   026   027   02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15AE035-76C8-4A18-B00F-C31C4C9B186E}"/>
              </a:ext>
            </a:extLst>
          </p:cNvPr>
          <p:cNvSpPr txBox="1"/>
          <p:nvPr/>
        </p:nvSpPr>
        <p:spPr>
          <a:xfrm>
            <a:off x="6457949" y="1790700"/>
            <a:ext cx="4224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029   031   036   039   041   042   043   044   045   04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E7F7712-7935-4BB8-918F-3872545A88FF}"/>
              </a:ext>
            </a:extLst>
          </p:cNvPr>
          <p:cNvSpPr txBox="1"/>
          <p:nvPr/>
        </p:nvSpPr>
        <p:spPr>
          <a:xfrm>
            <a:off x="6457949" y="3752849"/>
            <a:ext cx="4224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   049   052   054   055   056   058   059   060   061   063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C755F545-02D1-482D-A18B-30820579A9C1}"/>
              </a:ext>
            </a:extLst>
          </p:cNvPr>
          <p:cNvGrpSpPr/>
          <p:nvPr/>
        </p:nvGrpSpPr>
        <p:grpSpPr>
          <a:xfrm>
            <a:off x="811367" y="2098476"/>
            <a:ext cx="4355841" cy="1283095"/>
            <a:chOff x="811367" y="2098476"/>
            <a:chExt cx="4355841" cy="128309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038DD68-58E6-46E2-9AD3-B29FDA9DF8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032" t="16360" r="4141" b="10969"/>
            <a:stretch/>
          </p:blipFill>
          <p:spPr>
            <a:xfrm>
              <a:off x="838200" y="2098478"/>
              <a:ext cx="4329008" cy="1283093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46CE039-CCDD-40C2-B1ED-F2844B25F00C}"/>
                </a:ext>
              </a:extLst>
            </p:cNvPr>
            <p:cNvSpPr txBox="1"/>
            <p:nvPr/>
          </p:nvSpPr>
          <p:spPr>
            <a:xfrm>
              <a:off x="811367" y="209847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1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5D6EBB70-1811-40B9-998B-CBC3E92DA0E9}"/>
              </a:ext>
            </a:extLst>
          </p:cNvPr>
          <p:cNvGrpSpPr/>
          <p:nvPr/>
        </p:nvGrpSpPr>
        <p:grpSpPr>
          <a:xfrm>
            <a:off x="811367" y="4060626"/>
            <a:ext cx="4355841" cy="1283094"/>
            <a:chOff x="811367" y="4060626"/>
            <a:chExt cx="4355841" cy="128309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F6C73B3-E88E-46D7-B0F8-785369F367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619" t="26530" r="1579"/>
            <a:stretch/>
          </p:blipFill>
          <p:spPr>
            <a:xfrm>
              <a:off x="838200" y="4060626"/>
              <a:ext cx="4329008" cy="1283094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1BF9731-A466-401B-95FE-1E4A96666D03}"/>
                </a:ext>
              </a:extLst>
            </p:cNvPr>
            <p:cNvSpPr txBox="1"/>
            <p:nvPr/>
          </p:nvSpPr>
          <p:spPr>
            <a:xfrm>
              <a:off x="811367" y="406774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2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73E407A1-BEE5-453D-8E0A-608210569C61}"/>
              </a:ext>
            </a:extLst>
          </p:cNvPr>
          <p:cNvGrpSpPr/>
          <p:nvPr/>
        </p:nvGrpSpPr>
        <p:grpSpPr>
          <a:xfrm>
            <a:off x="6326342" y="2098476"/>
            <a:ext cx="4355841" cy="1283095"/>
            <a:chOff x="6326342" y="2098476"/>
            <a:chExt cx="4355841" cy="1283095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865E888-D6B5-492C-97A5-283D30C4A9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4013" t="6071" r="1797" b="21165"/>
            <a:stretch/>
          </p:blipFill>
          <p:spPr>
            <a:xfrm>
              <a:off x="6353174" y="2098476"/>
              <a:ext cx="4329009" cy="1283095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B0BABDF-2500-4700-BC16-4C7D9E86D279}"/>
                </a:ext>
              </a:extLst>
            </p:cNvPr>
            <p:cNvSpPr txBox="1"/>
            <p:nvPr/>
          </p:nvSpPr>
          <p:spPr>
            <a:xfrm>
              <a:off x="6326342" y="211067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3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7273AD15-007D-46B0-B903-CD9FF57940E4}"/>
              </a:ext>
            </a:extLst>
          </p:cNvPr>
          <p:cNvSpPr txBox="1"/>
          <p:nvPr/>
        </p:nvSpPr>
        <p:spPr>
          <a:xfrm>
            <a:off x="5382126" y="529390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9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1C1786E6-AA0A-485E-90A9-95E7D81752E3}"/>
              </a:ext>
            </a:extLst>
          </p:cNvPr>
          <p:cNvGrpSpPr/>
          <p:nvPr/>
        </p:nvGrpSpPr>
        <p:grpSpPr>
          <a:xfrm>
            <a:off x="6326342" y="4060626"/>
            <a:ext cx="4329008" cy="1283093"/>
            <a:chOff x="6326342" y="4060626"/>
            <a:chExt cx="4329008" cy="1283093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AAAB80EB-8FC2-4D3B-9882-B27F5F992D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507" t="23806" r="1875" b="3694"/>
            <a:stretch/>
          </p:blipFill>
          <p:spPr>
            <a:xfrm>
              <a:off x="6326342" y="4060626"/>
              <a:ext cx="4329008" cy="1283093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D77D0F4-C2AE-44A9-BAC2-2CD5EEE4F63B}"/>
                </a:ext>
              </a:extLst>
            </p:cNvPr>
            <p:cNvSpPr txBox="1"/>
            <p:nvPr/>
          </p:nvSpPr>
          <p:spPr>
            <a:xfrm>
              <a:off x="6326342" y="4066711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4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B433D07B-F05E-7C12-232A-D2B0487C8826}"/>
              </a:ext>
            </a:extLst>
          </p:cNvPr>
          <p:cNvSpPr txBox="1"/>
          <p:nvPr/>
        </p:nvSpPr>
        <p:spPr>
          <a:xfrm>
            <a:off x="2717055" y="5848511"/>
            <a:ext cx="72185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anti-CD9 (clone D3H4P; Cell Signaling Technology) at 1:5,000 rati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CFC17A0-92E1-4B08-68C3-3CB563FF9315}"/>
              </a:ext>
            </a:extLst>
          </p:cNvPr>
          <p:cNvSpPr txBox="1"/>
          <p:nvPr/>
        </p:nvSpPr>
        <p:spPr>
          <a:xfrm>
            <a:off x="2367642" y="6316261"/>
            <a:ext cx="9043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 (Body)"/>
                <a:ea typeface="DengXian" panose="02010600030101010101" pitchFamily="2" charset="-122"/>
              </a:rPr>
              <a:t>Secondary Antibody: Goat anti-Rabbit Alexa-Fluor 800 nm (Thermo Fisher Scientific) </a:t>
            </a:r>
            <a:endParaRPr lang="en-US" dirty="0">
              <a:latin typeface="Calibri (Body)"/>
            </a:endParaRPr>
          </a:p>
        </p:txBody>
      </p:sp>
    </p:spTree>
    <p:extLst>
      <p:ext uri="{BB962C8B-B14F-4D97-AF65-F5344CB8AC3E}">
        <p14:creationId xmlns:p14="http://schemas.microsoft.com/office/powerpoint/2010/main" val="2093613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769</Words>
  <Application>Microsoft Office PowerPoint</Application>
  <PresentationFormat>Widescreen</PresentationFormat>
  <Paragraphs>84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(Body)</vt:lpstr>
      <vt:lpstr>Calibri Light</vt:lpstr>
      <vt:lpstr>Office Theme</vt:lpstr>
      <vt:lpstr>Supplementary Figure 1c  Western blot detection of CD9 and LRRK2 proteins of 5 urine EV samples isolated by EVtrap or ultracentrifugation.</vt:lpstr>
      <vt:lpstr>PowerPoint Presentation</vt:lpstr>
      <vt:lpstr> Supplementary Figure 10a  All 20 urine EV samples were analyzed by Western Blot with anti-CD9, or anti-STK11, or anti-PCSK1N together with anti-HNRNPA1 antibodies (2 blots for each type). An equal amount of pooled urine EVs was loaded in lane 1 of each gel.  </vt:lpstr>
      <vt:lpstr>PowerPoint Presentation</vt:lpstr>
      <vt:lpstr>PowerPoint Presentation</vt:lpstr>
      <vt:lpstr>PowerPoint Presentation</vt:lpstr>
      <vt:lpstr>PowerPoint Presentation</vt:lpstr>
      <vt:lpstr> Supplementary Figure 11a  All 82 urine EV samples were analyzed by Western Blot with anti-CD9, anti-LRRK2, and anti-pSer1292-LRRK2 antibodies (8 blots for each type). An equal amount of a spike-in standard was loaded in lane 1 of each gel (pooled urine EVs for CD9 blots, recombinant LRRK2 for LRRK2 blots, and autophosphorylated recombinant LRRK2 for pSer1292-LRRK2 blots)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dyssey</dc:creator>
  <cp:lastModifiedBy>Hadisurya, Marco</cp:lastModifiedBy>
  <cp:revision>40</cp:revision>
  <dcterms:created xsi:type="dcterms:W3CDTF">2019-09-25T16:22:22Z</dcterms:created>
  <dcterms:modified xsi:type="dcterms:W3CDTF">2023-04-22T23:14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044bd30-2ed7-4c9d-9d12-46200872a97b_Enabled">
    <vt:lpwstr>true</vt:lpwstr>
  </property>
  <property fmtid="{D5CDD505-2E9C-101B-9397-08002B2CF9AE}" pid="3" name="MSIP_Label_4044bd30-2ed7-4c9d-9d12-46200872a97b_SetDate">
    <vt:lpwstr>2023-02-02T03:10:24Z</vt:lpwstr>
  </property>
  <property fmtid="{D5CDD505-2E9C-101B-9397-08002B2CF9AE}" pid="4" name="MSIP_Label_4044bd30-2ed7-4c9d-9d12-46200872a97b_Method">
    <vt:lpwstr>Standard</vt:lpwstr>
  </property>
  <property fmtid="{D5CDD505-2E9C-101B-9397-08002B2CF9AE}" pid="5" name="MSIP_Label_4044bd30-2ed7-4c9d-9d12-46200872a97b_Name">
    <vt:lpwstr>defa4170-0d19-0005-0004-bc88714345d2</vt:lpwstr>
  </property>
  <property fmtid="{D5CDD505-2E9C-101B-9397-08002B2CF9AE}" pid="6" name="MSIP_Label_4044bd30-2ed7-4c9d-9d12-46200872a97b_SiteId">
    <vt:lpwstr>4130bd39-7c53-419c-b1e5-8758d6d63f21</vt:lpwstr>
  </property>
  <property fmtid="{D5CDD505-2E9C-101B-9397-08002B2CF9AE}" pid="7" name="MSIP_Label_4044bd30-2ed7-4c9d-9d12-46200872a97b_ActionId">
    <vt:lpwstr>1c645d0c-4b43-497b-8485-906fbce88b7c</vt:lpwstr>
  </property>
  <property fmtid="{D5CDD505-2E9C-101B-9397-08002B2CF9AE}" pid="8" name="MSIP_Label_4044bd30-2ed7-4c9d-9d12-46200872a97b_ContentBits">
    <vt:lpwstr>0</vt:lpwstr>
  </property>
</Properties>
</file>